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1398" y="-1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5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5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5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90"/>
            </a:lvl2pPr>
            <a:lvl3pPr marL="514350" indent="0">
              <a:buNone/>
              <a:defRPr sz="675"/>
            </a:lvl3pPr>
            <a:lvl4pPr marL="771525" indent="0">
              <a:buNone/>
              <a:defRPr sz="565"/>
            </a:lvl4pPr>
            <a:lvl5pPr marL="1028700" indent="0">
              <a:buNone/>
              <a:defRPr sz="565"/>
            </a:lvl5pPr>
            <a:lvl6pPr marL="1285875" indent="0">
              <a:buNone/>
              <a:defRPr sz="565"/>
            </a:lvl6pPr>
            <a:lvl7pPr marL="1543050" indent="0">
              <a:buNone/>
              <a:defRPr sz="565"/>
            </a:lvl7pPr>
            <a:lvl8pPr marL="1800225" indent="0">
              <a:buNone/>
              <a:defRPr sz="565"/>
            </a:lvl8pPr>
            <a:lvl9pPr marL="2057400" indent="0">
              <a:buNone/>
              <a:defRPr sz="5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270" indent="-128270" algn="l" defTabSz="514350" rtl="0" eaLnBrk="1" latinLnBrk="0" hangingPunct="1">
        <a:lnSpc>
          <a:spcPct val="90000"/>
        </a:lnSpc>
        <a:spcBef>
          <a:spcPts val="565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445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620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899795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156970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414145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671320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928495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185670" indent="-128270" algn="l" defTabSz="514350" rtl="0" eaLnBrk="1" latinLnBrk="0" hangingPunct="1">
        <a:lnSpc>
          <a:spcPct val="90000"/>
        </a:lnSpc>
        <a:spcBef>
          <a:spcPts val="280"/>
        </a:spcBef>
        <a:buFont typeface="Arial" panose="020B0604020202020204" pitchFamily="34" charset="0"/>
        <a:buChar char="•"/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952500" y="6268224"/>
            <a:ext cx="525018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airwise sequence identity of full-length MYC proteins. A, B, C and D represent pairwise sequence identities of classes-1A, classes-1B, classes-2 and classes-3 MYC proteins, respectively. AB, AC, AD, BC, BD and CD represent pairwise sequence identities between classes-1A and -1B MYC proteins, classes-1A and -2 MYC proteins, classes-1A and -3 PG proteins, classes-1B and -2 MYC proteins, classes-1B and -3 MYC proteins, and classes-2 and -3 MYC proteins. The box plot shows the median (black line) and interquartile range (box). Outliers are shown as circles outside of the whiskers.</a:t>
            </a:r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1104900"/>
            <a:ext cx="4538472" cy="46482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88530" y="7137738"/>
            <a:ext cx="638556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The 3D structure of MYC proteins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3D structure of classes-1A (A), classes-1B (B), classes-2 (C) and classes-3 (D) in At sub-genome and part of Dt sub-genome were shown.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910" y="2502408"/>
            <a:ext cx="6490180" cy="3486912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948690" y="7353776"/>
            <a:ext cx="504063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 The sequence of motifs in </a:t>
            </a:r>
            <a:r>
              <a:rPr lang="en-US" altLang="zh-CN" sz="1800" b="1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hMYCs</a:t>
            </a:r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 total of 10 conserved motifs were identified in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hMYCs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, and the sequence of motifs were shown.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845" y="2735104"/>
            <a:ext cx="6304310" cy="3043214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411480" y="6681044"/>
            <a:ext cx="6248400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 The conserved sequence of MYC proteins from the nine plant species. 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147 MYC proteins from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. hirsutum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. barbadense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.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aimondii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rabidopsis thaliana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Oryza sativa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elaginella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ollendorffii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ymphaea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olorata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mborella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richopoda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and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hyscomitrella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patens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were used to perform multiple sequence alignment and visualization by using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lustal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-x, and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Jalview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The amino acid residues in the MYC were </a:t>
            </a:r>
            <a:r>
              <a:rPr lang="en-US" altLang="zh-CN" sz="1800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oloured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Red arrows indicate highly conserved positions of VALFI (hydrophobic core amino acid residues) residues.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996" y="1711121"/>
            <a:ext cx="5398008" cy="3998976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125730" y="7325975"/>
            <a:ext cx="618363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5 Genomic localization and collinearity analysis of </a:t>
            </a:r>
            <a:r>
              <a:rPr lang="en-US" altLang="zh-CN" sz="1800" b="1" i="1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hMYCs</a:t>
            </a:r>
            <a:r>
              <a:rPr lang="en-US" altLang="zh-CN" sz="18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altLang="zh-CN" sz="1800" b="1" kern="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he genomic localization and collinearity analysis of </a:t>
            </a:r>
            <a:r>
              <a:rPr lang="en-US" altLang="zh-CN" sz="1800" i="1" kern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GhMYCs</a:t>
            </a:r>
            <a:r>
              <a:rPr lang="en-US" altLang="zh-CN" sz="18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kern="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were shown in At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b-genome and part of Dt sub-genome of cotton genome by using PAML.</a:t>
            </a:r>
            <a:endParaRPr lang="zh-CN" altLang="zh-CN" sz="12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156" y="3286701"/>
            <a:ext cx="6647688" cy="184404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53</Words>
  <Application>WPS 演示</Application>
  <PresentationFormat>A4 纸张(210x297 毫米)</PresentationFormat>
  <Paragraphs>1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l w</dc:creator>
  <cp:lastModifiedBy>晨曦</cp:lastModifiedBy>
  <cp:revision>4</cp:revision>
  <dcterms:created xsi:type="dcterms:W3CDTF">2024-12-21T08:01:00Z</dcterms:created>
  <dcterms:modified xsi:type="dcterms:W3CDTF">2024-12-21T15:39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677A3294CC141E3A9382DDB78D17B9C_13</vt:lpwstr>
  </property>
  <property fmtid="{D5CDD505-2E9C-101B-9397-08002B2CF9AE}" pid="3" name="KSOProductBuildVer">
    <vt:lpwstr>2052-12.1.0.19302</vt:lpwstr>
  </property>
</Properties>
</file>